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fa-IR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A0D3748D-8D97-46FE-8F7D-9BEB07D2A948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1E86D7D3-40E9-4B8F-8B3B-A5466E1ACF22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857398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a-I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86D7D3-40E9-4B8F-8B3B-A5466E1ACF22}" type="slidenum">
              <a:rPr lang="fa-IR" smtClean="0"/>
              <a:t>2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273144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47231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74696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630134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41875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800509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011451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807075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780212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35197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87139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626300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411D1-1AEA-4F91-9497-75360E25D711}" type="datetimeFigureOut">
              <a:rPr lang="fa-IR" smtClean="0"/>
              <a:t>1445/10/22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A0921-BE0A-4531-8C44-7D4E7A0F4C3E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302486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eg"/><Relationship Id="rId18" Type="http://schemas.openxmlformats.org/officeDocument/2006/relationships/image" Target="../media/image17.pn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8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8.jpeg"/><Relationship Id="rId18" Type="http://schemas.openxmlformats.org/officeDocument/2006/relationships/image" Target="../media/image43.png"/><Relationship Id="rId26" Type="http://schemas.openxmlformats.org/officeDocument/2006/relationships/image" Target="../media/image48.jpeg"/><Relationship Id="rId39" Type="http://schemas.openxmlformats.org/officeDocument/2006/relationships/image" Target="../media/image61.jpeg"/><Relationship Id="rId21" Type="http://schemas.microsoft.com/office/2007/relationships/hdphoto" Target="../media/hdphoto7.wdp"/><Relationship Id="rId34" Type="http://schemas.openxmlformats.org/officeDocument/2006/relationships/image" Target="../media/image56.jpeg"/><Relationship Id="rId42" Type="http://schemas.openxmlformats.org/officeDocument/2006/relationships/image" Target="../media/image64.jpeg"/><Relationship Id="rId47" Type="http://schemas.openxmlformats.org/officeDocument/2006/relationships/image" Target="../media/image69.jpeg"/><Relationship Id="rId50" Type="http://schemas.openxmlformats.org/officeDocument/2006/relationships/image" Target="../media/image72.jpeg"/><Relationship Id="rId55" Type="http://schemas.openxmlformats.org/officeDocument/2006/relationships/image" Target="../media/image77.jpe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1.jpeg"/><Relationship Id="rId29" Type="http://schemas.openxmlformats.org/officeDocument/2006/relationships/image" Target="../media/image51.jpeg"/><Relationship Id="rId11" Type="http://schemas.openxmlformats.org/officeDocument/2006/relationships/image" Target="../media/image37.png"/><Relationship Id="rId24" Type="http://schemas.microsoft.com/office/2007/relationships/hdphoto" Target="../media/hdphoto8.wdp"/><Relationship Id="rId32" Type="http://schemas.openxmlformats.org/officeDocument/2006/relationships/image" Target="../media/image54.jpeg"/><Relationship Id="rId37" Type="http://schemas.openxmlformats.org/officeDocument/2006/relationships/image" Target="../media/image59.jpeg"/><Relationship Id="rId40" Type="http://schemas.openxmlformats.org/officeDocument/2006/relationships/image" Target="../media/image62.png"/><Relationship Id="rId45" Type="http://schemas.openxmlformats.org/officeDocument/2006/relationships/image" Target="../media/image67.jpeg"/><Relationship Id="rId53" Type="http://schemas.openxmlformats.org/officeDocument/2006/relationships/image" Target="../media/image75.jpeg"/><Relationship Id="rId5" Type="http://schemas.openxmlformats.org/officeDocument/2006/relationships/image" Target="../media/image34.png"/><Relationship Id="rId10" Type="http://schemas.microsoft.com/office/2007/relationships/hdphoto" Target="../media/hdphoto4.wdp"/><Relationship Id="rId19" Type="http://schemas.microsoft.com/office/2007/relationships/hdphoto" Target="../media/hdphoto6.wdp"/><Relationship Id="rId31" Type="http://schemas.openxmlformats.org/officeDocument/2006/relationships/image" Target="../media/image53.jpeg"/><Relationship Id="rId44" Type="http://schemas.openxmlformats.org/officeDocument/2006/relationships/image" Target="../media/image66.jpeg"/><Relationship Id="rId52" Type="http://schemas.openxmlformats.org/officeDocument/2006/relationships/image" Target="../media/image74.jpeg"/><Relationship Id="rId4" Type="http://schemas.microsoft.com/office/2007/relationships/hdphoto" Target="../media/hdphoto1.wdp"/><Relationship Id="rId9" Type="http://schemas.openxmlformats.org/officeDocument/2006/relationships/image" Target="../media/image36.png"/><Relationship Id="rId14" Type="http://schemas.openxmlformats.org/officeDocument/2006/relationships/image" Target="../media/image39.jpeg"/><Relationship Id="rId22" Type="http://schemas.openxmlformats.org/officeDocument/2006/relationships/image" Target="../media/image45.jpeg"/><Relationship Id="rId27" Type="http://schemas.openxmlformats.org/officeDocument/2006/relationships/image" Target="../media/image49.jpeg"/><Relationship Id="rId30" Type="http://schemas.openxmlformats.org/officeDocument/2006/relationships/image" Target="../media/image52.jpeg"/><Relationship Id="rId35" Type="http://schemas.openxmlformats.org/officeDocument/2006/relationships/image" Target="../media/image57.jpeg"/><Relationship Id="rId43" Type="http://schemas.openxmlformats.org/officeDocument/2006/relationships/image" Target="../media/image65.jpeg"/><Relationship Id="rId48" Type="http://schemas.openxmlformats.org/officeDocument/2006/relationships/image" Target="../media/image70.jpeg"/><Relationship Id="rId8" Type="http://schemas.microsoft.com/office/2007/relationships/hdphoto" Target="../media/hdphoto3.wdp"/><Relationship Id="rId51" Type="http://schemas.openxmlformats.org/officeDocument/2006/relationships/image" Target="../media/image73.jpeg"/><Relationship Id="rId3" Type="http://schemas.openxmlformats.org/officeDocument/2006/relationships/image" Target="../media/image33.png"/><Relationship Id="rId12" Type="http://schemas.microsoft.com/office/2007/relationships/hdphoto" Target="../media/hdphoto5.wdp"/><Relationship Id="rId17" Type="http://schemas.openxmlformats.org/officeDocument/2006/relationships/image" Target="../media/image42.jpeg"/><Relationship Id="rId25" Type="http://schemas.openxmlformats.org/officeDocument/2006/relationships/image" Target="../media/image47.jpeg"/><Relationship Id="rId33" Type="http://schemas.openxmlformats.org/officeDocument/2006/relationships/image" Target="../media/image55.jpeg"/><Relationship Id="rId38" Type="http://schemas.openxmlformats.org/officeDocument/2006/relationships/image" Target="../media/image60.jpeg"/><Relationship Id="rId46" Type="http://schemas.openxmlformats.org/officeDocument/2006/relationships/image" Target="../media/image68.jpeg"/><Relationship Id="rId20" Type="http://schemas.openxmlformats.org/officeDocument/2006/relationships/image" Target="../media/image44.png"/><Relationship Id="rId41" Type="http://schemas.openxmlformats.org/officeDocument/2006/relationships/image" Target="../media/image63.jpeg"/><Relationship Id="rId54" Type="http://schemas.openxmlformats.org/officeDocument/2006/relationships/image" Target="../media/image76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5" Type="http://schemas.openxmlformats.org/officeDocument/2006/relationships/image" Target="../media/image40.jpeg"/><Relationship Id="rId23" Type="http://schemas.openxmlformats.org/officeDocument/2006/relationships/image" Target="../media/image46.png"/><Relationship Id="rId28" Type="http://schemas.openxmlformats.org/officeDocument/2006/relationships/image" Target="../media/image50.jpeg"/><Relationship Id="rId36" Type="http://schemas.openxmlformats.org/officeDocument/2006/relationships/image" Target="../media/image58.jpeg"/><Relationship Id="rId49" Type="http://schemas.openxmlformats.org/officeDocument/2006/relationships/image" Target="../media/image71.jpeg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9.png"/><Relationship Id="rId18" Type="http://schemas.openxmlformats.org/officeDocument/2006/relationships/image" Target="../media/image94.jpeg"/><Relationship Id="rId26" Type="http://schemas.openxmlformats.org/officeDocument/2006/relationships/image" Target="../media/image102.jpeg"/><Relationship Id="rId39" Type="http://schemas.openxmlformats.org/officeDocument/2006/relationships/image" Target="../media/image115.jpeg"/><Relationship Id="rId21" Type="http://schemas.openxmlformats.org/officeDocument/2006/relationships/image" Target="../media/image97.png"/><Relationship Id="rId34" Type="http://schemas.openxmlformats.org/officeDocument/2006/relationships/image" Target="../media/image110.png"/><Relationship Id="rId42" Type="http://schemas.openxmlformats.org/officeDocument/2006/relationships/image" Target="../media/image118.png"/><Relationship Id="rId7" Type="http://schemas.openxmlformats.org/officeDocument/2006/relationships/image" Target="../media/image83.jpeg"/><Relationship Id="rId2" Type="http://schemas.openxmlformats.org/officeDocument/2006/relationships/image" Target="../media/image78.jpeg"/><Relationship Id="rId16" Type="http://schemas.openxmlformats.org/officeDocument/2006/relationships/image" Target="../media/image92.png"/><Relationship Id="rId29" Type="http://schemas.openxmlformats.org/officeDocument/2006/relationships/image" Target="../media/image10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2.png"/><Relationship Id="rId11" Type="http://schemas.openxmlformats.org/officeDocument/2006/relationships/image" Target="../media/image87.jpeg"/><Relationship Id="rId24" Type="http://schemas.openxmlformats.org/officeDocument/2006/relationships/image" Target="../media/image100.jpeg"/><Relationship Id="rId32" Type="http://schemas.openxmlformats.org/officeDocument/2006/relationships/image" Target="../media/image108.jpeg"/><Relationship Id="rId37" Type="http://schemas.openxmlformats.org/officeDocument/2006/relationships/image" Target="../media/image113.jpeg"/><Relationship Id="rId40" Type="http://schemas.openxmlformats.org/officeDocument/2006/relationships/image" Target="../media/image116.jpeg"/><Relationship Id="rId45" Type="http://schemas.openxmlformats.org/officeDocument/2006/relationships/image" Target="../media/image121.png"/><Relationship Id="rId5" Type="http://schemas.openxmlformats.org/officeDocument/2006/relationships/image" Target="../media/image81.png"/><Relationship Id="rId15" Type="http://schemas.openxmlformats.org/officeDocument/2006/relationships/image" Target="../media/image91.jpeg"/><Relationship Id="rId23" Type="http://schemas.openxmlformats.org/officeDocument/2006/relationships/image" Target="../media/image99.png"/><Relationship Id="rId28" Type="http://schemas.openxmlformats.org/officeDocument/2006/relationships/image" Target="../media/image104.jpeg"/><Relationship Id="rId36" Type="http://schemas.openxmlformats.org/officeDocument/2006/relationships/image" Target="../media/image112.png"/><Relationship Id="rId10" Type="http://schemas.openxmlformats.org/officeDocument/2006/relationships/image" Target="../media/image86.jpeg"/><Relationship Id="rId19" Type="http://schemas.openxmlformats.org/officeDocument/2006/relationships/image" Target="../media/image95.jpeg"/><Relationship Id="rId31" Type="http://schemas.openxmlformats.org/officeDocument/2006/relationships/image" Target="../media/image107.png"/><Relationship Id="rId44" Type="http://schemas.openxmlformats.org/officeDocument/2006/relationships/image" Target="../media/image120.png"/><Relationship Id="rId4" Type="http://schemas.openxmlformats.org/officeDocument/2006/relationships/image" Target="../media/image80.jpeg"/><Relationship Id="rId9" Type="http://schemas.openxmlformats.org/officeDocument/2006/relationships/image" Target="../media/image85.png"/><Relationship Id="rId14" Type="http://schemas.openxmlformats.org/officeDocument/2006/relationships/image" Target="../media/image90.jpeg"/><Relationship Id="rId22" Type="http://schemas.openxmlformats.org/officeDocument/2006/relationships/image" Target="../media/image98.png"/><Relationship Id="rId27" Type="http://schemas.openxmlformats.org/officeDocument/2006/relationships/image" Target="../media/image103.jpeg"/><Relationship Id="rId30" Type="http://schemas.openxmlformats.org/officeDocument/2006/relationships/image" Target="../media/image106.png"/><Relationship Id="rId35" Type="http://schemas.openxmlformats.org/officeDocument/2006/relationships/image" Target="../media/image111.jpeg"/><Relationship Id="rId43" Type="http://schemas.openxmlformats.org/officeDocument/2006/relationships/image" Target="../media/image119.png"/><Relationship Id="rId8" Type="http://schemas.openxmlformats.org/officeDocument/2006/relationships/image" Target="../media/image84.jpeg"/><Relationship Id="rId3" Type="http://schemas.openxmlformats.org/officeDocument/2006/relationships/image" Target="../media/image79.jpeg"/><Relationship Id="rId12" Type="http://schemas.openxmlformats.org/officeDocument/2006/relationships/image" Target="../media/image88.jpeg"/><Relationship Id="rId17" Type="http://schemas.openxmlformats.org/officeDocument/2006/relationships/image" Target="../media/image93.jpeg"/><Relationship Id="rId25" Type="http://schemas.openxmlformats.org/officeDocument/2006/relationships/image" Target="../media/image101.jpeg"/><Relationship Id="rId33" Type="http://schemas.openxmlformats.org/officeDocument/2006/relationships/image" Target="../media/image109.jpeg"/><Relationship Id="rId38" Type="http://schemas.openxmlformats.org/officeDocument/2006/relationships/image" Target="../media/image114.jpeg"/><Relationship Id="rId46" Type="http://schemas.openxmlformats.org/officeDocument/2006/relationships/image" Target="../media/image122.png"/><Relationship Id="rId20" Type="http://schemas.openxmlformats.org/officeDocument/2006/relationships/image" Target="../media/image96.jpeg"/><Relationship Id="rId41" Type="http://schemas.openxmlformats.org/officeDocument/2006/relationships/image" Target="../media/image1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77" y="100075"/>
            <a:ext cx="1250007" cy="128034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41" name="Rectangle 40"/>
          <p:cNvSpPr/>
          <p:nvPr/>
        </p:nvSpPr>
        <p:spPr>
          <a:xfrm>
            <a:off x="139007" y="57150"/>
            <a:ext cx="1139613" cy="296631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33-01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1" name="Group 100"/>
          <p:cNvGrpSpPr/>
          <p:nvPr/>
        </p:nvGrpSpPr>
        <p:grpSpPr>
          <a:xfrm>
            <a:off x="1400799" y="58869"/>
            <a:ext cx="10719654" cy="1307218"/>
            <a:chOff x="84740" y="2655183"/>
            <a:chExt cx="10719654" cy="1307218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740" y="2701227"/>
              <a:ext cx="1230702" cy="126117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3" name="Rectangle 42"/>
            <p:cNvSpPr/>
            <p:nvPr/>
          </p:nvSpPr>
          <p:spPr>
            <a:xfrm>
              <a:off x="158299" y="265518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4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7272" y="2696391"/>
              <a:ext cx="1285227" cy="126601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5" name="Rectangle 44"/>
            <p:cNvSpPr/>
            <p:nvPr/>
          </p:nvSpPr>
          <p:spPr>
            <a:xfrm>
              <a:off x="1456831" y="2665126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5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7652" y="2682161"/>
              <a:ext cx="1185550" cy="128023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7" name="Rectangle 46"/>
            <p:cNvSpPr/>
            <p:nvPr/>
          </p:nvSpPr>
          <p:spPr>
            <a:xfrm>
              <a:off x="2758636" y="2696390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6-0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3617" y="2682161"/>
              <a:ext cx="1323152" cy="128023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9" name="Rectangle 48"/>
            <p:cNvSpPr/>
            <p:nvPr/>
          </p:nvSpPr>
          <p:spPr>
            <a:xfrm>
              <a:off x="4073402" y="2665126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7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53450" y="2696390"/>
              <a:ext cx="1321697" cy="126601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1" name="Rectangle 50"/>
            <p:cNvSpPr/>
            <p:nvPr/>
          </p:nvSpPr>
          <p:spPr>
            <a:xfrm>
              <a:off x="5472507" y="2696389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8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7386" y="2696389"/>
              <a:ext cx="1314321" cy="126601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3" name="Rectangle 52"/>
            <p:cNvSpPr/>
            <p:nvPr/>
          </p:nvSpPr>
          <p:spPr>
            <a:xfrm>
              <a:off x="6870885" y="2696389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9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59268" y="2696389"/>
              <a:ext cx="1285193" cy="126601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5" name="Rectangle 54"/>
            <p:cNvSpPr/>
            <p:nvPr/>
          </p:nvSpPr>
          <p:spPr>
            <a:xfrm>
              <a:off x="8220340" y="2677040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0-0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85061" y="2696389"/>
              <a:ext cx="1319333" cy="126601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7" name="Rectangle 56"/>
            <p:cNvSpPr/>
            <p:nvPr/>
          </p:nvSpPr>
          <p:spPr>
            <a:xfrm>
              <a:off x="9591405" y="2716814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1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58" name="Picture 5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487" y="1423344"/>
            <a:ext cx="1238897" cy="1266011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9" name="Rectangle 58"/>
          <p:cNvSpPr/>
          <p:nvPr/>
        </p:nvSpPr>
        <p:spPr>
          <a:xfrm>
            <a:off x="140948" y="1403140"/>
            <a:ext cx="1083581" cy="280079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42-01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2" name="Group 101"/>
          <p:cNvGrpSpPr/>
          <p:nvPr/>
        </p:nvGrpSpPr>
        <p:grpSpPr>
          <a:xfrm>
            <a:off x="1428738" y="1366086"/>
            <a:ext cx="10664153" cy="1323269"/>
            <a:chOff x="84739" y="3986903"/>
            <a:chExt cx="10664153" cy="1402515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84739" y="4033626"/>
              <a:ext cx="1247969" cy="135579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1" name="Rectangle 60"/>
            <p:cNvSpPr/>
            <p:nvPr/>
          </p:nvSpPr>
          <p:spPr>
            <a:xfrm>
              <a:off x="166932" y="4008444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3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00799" y="4047138"/>
              <a:ext cx="1261700" cy="132876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3" name="Rectangle 62"/>
            <p:cNvSpPr/>
            <p:nvPr/>
          </p:nvSpPr>
          <p:spPr>
            <a:xfrm>
              <a:off x="1489858" y="400844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4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7652" y="4031726"/>
              <a:ext cx="1185549" cy="135769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5" name="Rectangle 64"/>
            <p:cNvSpPr/>
            <p:nvPr/>
          </p:nvSpPr>
          <p:spPr>
            <a:xfrm>
              <a:off x="2730589" y="399174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5-1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8382" y="4047138"/>
              <a:ext cx="1347339" cy="134227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7" name="Rectangle 66"/>
            <p:cNvSpPr/>
            <p:nvPr/>
          </p:nvSpPr>
          <p:spPr>
            <a:xfrm>
              <a:off x="4037443" y="398690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6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34733" y="4018211"/>
              <a:ext cx="1355236" cy="135769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9" name="Rectangle 68"/>
            <p:cNvSpPr/>
            <p:nvPr/>
          </p:nvSpPr>
          <p:spPr>
            <a:xfrm>
              <a:off x="5470640" y="400844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7-08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0" name="Picture 69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49463" y="4008443"/>
              <a:ext cx="1314321" cy="138097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1" name="Rectangle 70"/>
            <p:cNvSpPr/>
            <p:nvPr/>
          </p:nvSpPr>
          <p:spPr>
            <a:xfrm>
              <a:off x="6876340" y="4003677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8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26062" y="4008444"/>
              <a:ext cx="1322629" cy="136746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3" name="Rectangle 72"/>
            <p:cNvSpPr/>
            <p:nvPr/>
          </p:nvSpPr>
          <p:spPr>
            <a:xfrm>
              <a:off x="8193370" y="3986903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49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4" name="Picture 73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83894" y="4031725"/>
              <a:ext cx="1264998" cy="134417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5" name="Rectangle 74"/>
            <p:cNvSpPr/>
            <p:nvPr/>
          </p:nvSpPr>
          <p:spPr>
            <a:xfrm>
              <a:off x="9593170" y="3993964"/>
              <a:ext cx="1083581" cy="28007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0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76" name="Picture 75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52" y="2753313"/>
            <a:ext cx="1231632" cy="129048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7" name="Rectangle 76"/>
          <p:cNvSpPr/>
          <p:nvPr/>
        </p:nvSpPr>
        <p:spPr>
          <a:xfrm>
            <a:off x="182777" y="2732280"/>
            <a:ext cx="1083581" cy="280079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52-01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" name="Group 102"/>
          <p:cNvGrpSpPr/>
          <p:nvPr/>
        </p:nvGrpSpPr>
        <p:grpSpPr>
          <a:xfrm>
            <a:off x="1414409" y="2699366"/>
            <a:ext cx="10667437" cy="1344430"/>
            <a:chOff x="83944" y="5414600"/>
            <a:chExt cx="10667437" cy="1344430"/>
          </a:xfrm>
        </p:grpSpPr>
        <p:pic>
          <p:nvPicPr>
            <p:cNvPr id="78" name="Picture 7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44" y="5460643"/>
              <a:ext cx="1248764" cy="129838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9" name="Rectangle 78"/>
            <p:cNvSpPr/>
            <p:nvPr/>
          </p:nvSpPr>
          <p:spPr>
            <a:xfrm>
              <a:off x="166932" y="5428504"/>
              <a:ext cx="1083581" cy="25545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3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3076" y="5458744"/>
              <a:ext cx="1274009" cy="130028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1" name="Rectangle 80"/>
            <p:cNvSpPr/>
            <p:nvPr/>
          </p:nvSpPr>
          <p:spPr>
            <a:xfrm>
              <a:off x="1486254" y="5414600"/>
              <a:ext cx="1083581" cy="26935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4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2" name="Picture 8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5428" y="5458744"/>
              <a:ext cx="1247525" cy="130028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3" name="Rectangle 82"/>
            <p:cNvSpPr/>
            <p:nvPr/>
          </p:nvSpPr>
          <p:spPr>
            <a:xfrm>
              <a:off x="2758636" y="5419326"/>
              <a:ext cx="1083581" cy="2646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6-0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4" name="Picture 83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2814" y="5458744"/>
              <a:ext cx="1347097" cy="130028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5" name="Rectangle 84"/>
            <p:cNvSpPr/>
            <p:nvPr/>
          </p:nvSpPr>
          <p:spPr>
            <a:xfrm>
              <a:off x="4073402" y="5417640"/>
              <a:ext cx="1083581" cy="26631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7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6" name="Picture 85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53450" y="5443476"/>
              <a:ext cx="1396013" cy="130099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7" name="Rectangle 86"/>
            <p:cNvSpPr/>
            <p:nvPr/>
          </p:nvSpPr>
          <p:spPr>
            <a:xfrm>
              <a:off x="5530741" y="5425516"/>
              <a:ext cx="1083581" cy="23371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8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8" name="Picture 87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4771" y="5428504"/>
              <a:ext cx="1326969" cy="131596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9" name="Rectangle 88"/>
            <p:cNvSpPr/>
            <p:nvPr/>
          </p:nvSpPr>
          <p:spPr>
            <a:xfrm>
              <a:off x="6864832" y="5428504"/>
              <a:ext cx="1083581" cy="25545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59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0" name="Picture 89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46023" y="5428504"/>
              <a:ext cx="1316202" cy="130941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1" name="Rectangle 90"/>
            <p:cNvSpPr/>
            <p:nvPr/>
          </p:nvSpPr>
          <p:spPr>
            <a:xfrm>
              <a:off x="8220340" y="5414600"/>
              <a:ext cx="1083581" cy="26935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60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01347" y="5418210"/>
              <a:ext cx="1250034" cy="132626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3" name="Rectangle 92"/>
            <p:cNvSpPr/>
            <p:nvPr/>
          </p:nvSpPr>
          <p:spPr>
            <a:xfrm>
              <a:off x="9632455" y="5428503"/>
              <a:ext cx="1083581" cy="26617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61-0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4" name="Picture 93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52" y="4107755"/>
            <a:ext cx="1231632" cy="1306845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96" name="Rectangle 95"/>
          <p:cNvSpPr/>
          <p:nvPr/>
        </p:nvSpPr>
        <p:spPr>
          <a:xfrm>
            <a:off x="139007" y="4064830"/>
            <a:ext cx="1083581" cy="26935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63-04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4" name="Picture 103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3956" y="4110853"/>
            <a:ext cx="1237545" cy="1303747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106" name="Rectangle 105"/>
          <p:cNvSpPr/>
          <p:nvPr/>
        </p:nvSpPr>
        <p:spPr>
          <a:xfrm>
            <a:off x="1470937" y="4107755"/>
            <a:ext cx="1083581" cy="26935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64-10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7" name="Picture 106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7689" y="4072363"/>
            <a:ext cx="1278824" cy="1342237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108" name="Rectangle 107"/>
          <p:cNvSpPr/>
          <p:nvPr/>
        </p:nvSpPr>
        <p:spPr>
          <a:xfrm>
            <a:off x="2794153" y="4064676"/>
            <a:ext cx="1083581" cy="26935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65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7039" y="4090210"/>
            <a:ext cx="1218643" cy="131346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110" name="Rectangle 109"/>
          <p:cNvSpPr/>
          <p:nvPr/>
        </p:nvSpPr>
        <p:spPr>
          <a:xfrm>
            <a:off x="4104569" y="4090950"/>
            <a:ext cx="1083581" cy="26935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66-05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1" name="Picture 110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2102" y="4091332"/>
            <a:ext cx="1280726" cy="1323268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112" name="Rectangle 111"/>
          <p:cNvSpPr/>
          <p:nvPr/>
        </p:nvSpPr>
        <p:spPr>
          <a:xfrm>
            <a:off x="5389461" y="4097951"/>
            <a:ext cx="1083581" cy="26935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67-01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6678732" y="4175821"/>
            <a:ext cx="5403114" cy="1200601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l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Example seed images of </a:t>
            </a:r>
            <a:r>
              <a:rPr lang="en-US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b="1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tua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b="1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rilis</a:t>
            </a:r>
            <a:r>
              <a:rPr lang="en-US" b="1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2 locations with sampling codes used in our study for ANN models. </a:t>
            </a:r>
            <a:r>
              <a:rPr lang="fa-IR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</a:p>
        </p:txBody>
      </p:sp>
    </p:spTree>
    <p:extLst>
      <p:ext uri="{BB962C8B-B14F-4D97-AF65-F5344CB8AC3E}">
        <p14:creationId xmlns:p14="http://schemas.microsoft.com/office/powerpoint/2010/main" val="1401597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73128" y="44369"/>
            <a:ext cx="8116359" cy="1326551"/>
            <a:chOff x="51250" y="82426"/>
            <a:chExt cx="8138173" cy="1311029"/>
          </a:xfrm>
        </p:grpSpPr>
        <p:grpSp>
          <p:nvGrpSpPr>
            <p:cNvPr id="12" name="Group 11"/>
            <p:cNvGrpSpPr/>
            <p:nvPr/>
          </p:nvGrpSpPr>
          <p:grpSpPr>
            <a:xfrm>
              <a:off x="51250" y="109383"/>
              <a:ext cx="5549389" cy="1284072"/>
              <a:chOff x="52774" y="82084"/>
              <a:chExt cx="5714421" cy="1284072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774" y="82980"/>
                <a:ext cx="1384352" cy="1283176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00450" y="86174"/>
                <a:ext cx="1362237" cy="1279982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22764" y="82980"/>
                <a:ext cx="1398973" cy="1270283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55965" y="82084"/>
                <a:ext cx="1411230" cy="1270282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</p:grpSp>
        <p:sp>
          <p:nvSpPr>
            <p:cNvPr id="14" name="Rectangle 13"/>
            <p:cNvSpPr/>
            <p:nvPr/>
          </p:nvSpPr>
          <p:spPr>
            <a:xfrm>
              <a:off x="153629" y="110279"/>
              <a:ext cx="1139613" cy="24623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G01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1558932" y="92790"/>
              <a:ext cx="1139613" cy="235144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G02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922602" y="116914"/>
              <a:ext cx="1139613" cy="25559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G03-06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349733" y="87251"/>
              <a:ext cx="1139613" cy="26926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H01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22195" y="106164"/>
              <a:ext cx="1308424" cy="128317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9" name="Rectangle 18"/>
            <p:cNvSpPr/>
            <p:nvPr/>
          </p:nvSpPr>
          <p:spPr>
            <a:xfrm>
              <a:off x="5695527" y="88790"/>
              <a:ext cx="1139613" cy="26772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H02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8404" y="108066"/>
              <a:ext cx="1251019" cy="124556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1" name="Rectangle 20"/>
            <p:cNvSpPr/>
            <p:nvPr/>
          </p:nvSpPr>
          <p:spPr>
            <a:xfrm>
              <a:off x="7028608" y="82426"/>
              <a:ext cx="1139613" cy="28247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H03-08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4" name="Picture 2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4273" y="71658"/>
            <a:ext cx="1226897" cy="128645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25" name="Rectangle 24"/>
          <p:cNvSpPr/>
          <p:nvPr/>
        </p:nvSpPr>
        <p:spPr>
          <a:xfrm>
            <a:off x="8297914" y="44369"/>
            <a:ext cx="1139613" cy="312159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H04-08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0" name="Group 49"/>
          <p:cNvGrpSpPr/>
          <p:nvPr/>
        </p:nvGrpSpPr>
        <p:grpSpPr>
          <a:xfrm>
            <a:off x="73130" y="58469"/>
            <a:ext cx="12027354" cy="2629314"/>
            <a:chOff x="73130" y="58469"/>
            <a:chExt cx="12027354" cy="2629314"/>
          </a:xfrm>
        </p:grpSpPr>
        <p:grpSp>
          <p:nvGrpSpPr>
            <p:cNvPr id="2" name="Group 1"/>
            <p:cNvGrpSpPr/>
            <p:nvPr/>
          </p:nvGrpSpPr>
          <p:grpSpPr>
            <a:xfrm>
              <a:off x="73130" y="58469"/>
              <a:ext cx="12027354" cy="2629314"/>
              <a:chOff x="2112513" y="24897"/>
              <a:chExt cx="13539088" cy="3191188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751406" y="43935"/>
                <a:ext cx="1521305" cy="1507049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12934537" y="24897"/>
                <a:ext cx="1136400" cy="361753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H05-09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78975" y="36841"/>
                <a:ext cx="1372626" cy="1580973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29" name="Rectangle 28"/>
              <p:cNvSpPr/>
              <p:nvPr/>
            </p:nvSpPr>
            <p:spPr>
              <a:xfrm>
                <a:off x="14395480" y="56012"/>
                <a:ext cx="1139613" cy="326731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H06-03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12513" y="1688573"/>
                <a:ext cx="1488718" cy="1527512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31" name="Rectangle 30"/>
              <p:cNvSpPr/>
              <p:nvPr/>
            </p:nvSpPr>
            <p:spPr>
              <a:xfrm>
                <a:off x="2203130" y="1662082"/>
                <a:ext cx="1139613" cy="259288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H07-09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2" name="Picture 31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90540" y="1687106"/>
                <a:ext cx="1469088" cy="1528979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33" name="Rectangle 32"/>
              <p:cNvSpPr/>
              <p:nvPr/>
            </p:nvSpPr>
            <p:spPr>
              <a:xfrm>
                <a:off x="3845234" y="1655599"/>
                <a:ext cx="1139613" cy="271046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H08-03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24346" y="1653551"/>
                <a:ext cx="1530289" cy="1562533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35" name="Rectangle 34"/>
              <p:cNvSpPr/>
              <p:nvPr/>
            </p:nvSpPr>
            <p:spPr>
              <a:xfrm>
                <a:off x="5419683" y="1619135"/>
                <a:ext cx="1139613" cy="307511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H09-01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39366" y="1423677"/>
              <a:ext cx="1349988" cy="126410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7" name="Rectangle 36"/>
            <p:cNvSpPr/>
            <p:nvPr/>
          </p:nvSpPr>
          <p:spPr>
            <a:xfrm>
              <a:off x="4344553" y="1388939"/>
              <a:ext cx="1139613" cy="23643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H10-1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5445" y="1400365"/>
              <a:ext cx="1274698" cy="128741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9" name="Rectangle 38"/>
            <p:cNvSpPr/>
            <p:nvPr/>
          </p:nvSpPr>
          <p:spPr>
            <a:xfrm>
              <a:off x="5696731" y="1395983"/>
              <a:ext cx="1139613" cy="22939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H11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62855" y="1341317"/>
            <a:ext cx="12037630" cy="2556880"/>
            <a:chOff x="62855" y="1341317"/>
            <a:chExt cx="12037630" cy="2556880"/>
          </a:xfrm>
        </p:grpSpPr>
        <p:grpSp>
          <p:nvGrpSpPr>
            <p:cNvPr id="3" name="Group 2"/>
            <p:cNvGrpSpPr/>
            <p:nvPr/>
          </p:nvGrpSpPr>
          <p:grpSpPr>
            <a:xfrm>
              <a:off x="6971431" y="1356888"/>
              <a:ext cx="3874027" cy="1330894"/>
              <a:chOff x="11155528" y="2097367"/>
              <a:chExt cx="3935658" cy="1330894"/>
            </a:xfrm>
          </p:grpSpPr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155528" y="2160503"/>
                <a:ext cx="1261858" cy="126775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41" name="Rectangle 40"/>
              <p:cNvSpPr/>
              <p:nvPr/>
            </p:nvSpPr>
            <p:spPr>
              <a:xfrm>
                <a:off x="11208340" y="2124099"/>
                <a:ext cx="1139613" cy="269509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01-03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461876" y="2117229"/>
                <a:ext cx="1243320" cy="1311032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43" name="Rectangle 42"/>
              <p:cNvSpPr/>
              <p:nvPr/>
            </p:nvSpPr>
            <p:spPr>
              <a:xfrm>
                <a:off x="12512139" y="2097367"/>
                <a:ext cx="1139613" cy="241576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01-07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4" name="Picture 43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749686" y="2110218"/>
                <a:ext cx="1341500" cy="1318043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45" name="Rectangle 44"/>
              <p:cNvSpPr/>
              <p:nvPr/>
            </p:nvSpPr>
            <p:spPr>
              <a:xfrm>
                <a:off x="13823775" y="2120120"/>
                <a:ext cx="1139613" cy="245735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O02-02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59157" y="1341317"/>
              <a:ext cx="1241328" cy="134646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6" name="Rectangle 45"/>
            <p:cNvSpPr/>
            <p:nvPr/>
          </p:nvSpPr>
          <p:spPr>
            <a:xfrm>
              <a:off x="10941858" y="1369739"/>
              <a:ext cx="1121767" cy="228724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ZK01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55" y="2714584"/>
              <a:ext cx="1321160" cy="118361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7" name="Rectangle 46"/>
            <p:cNvSpPr/>
            <p:nvPr/>
          </p:nvSpPr>
          <p:spPr>
            <a:xfrm>
              <a:off x="149390" y="2687782"/>
              <a:ext cx="1121767" cy="266501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ZK02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7117" y="2758133"/>
              <a:ext cx="1322896" cy="113549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8" name="Rectangle 47"/>
            <p:cNvSpPr/>
            <p:nvPr/>
          </p:nvSpPr>
          <p:spPr>
            <a:xfrm>
              <a:off x="1557680" y="2744875"/>
              <a:ext cx="1121767" cy="267714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ZK03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3112" y="2758134"/>
              <a:ext cx="1343814" cy="113549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9" name="Rectangle 48"/>
            <p:cNvSpPr/>
            <p:nvPr/>
          </p:nvSpPr>
          <p:spPr>
            <a:xfrm>
              <a:off x="2931524" y="2730038"/>
              <a:ext cx="1121767" cy="244544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ZK04-0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52" name="Picture 51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9371" y="2758133"/>
            <a:ext cx="1361429" cy="116534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3" name="Rectangle 52"/>
          <p:cNvSpPr/>
          <p:nvPr/>
        </p:nvSpPr>
        <p:spPr>
          <a:xfrm>
            <a:off x="4341943" y="2730038"/>
            <a:ext cx="1121767" cy="224245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01-09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6024" y="2744875"/>
            <a:ext cx="1296484" cy="1178601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5" name="Rectangle 54"/>
          <p:cNvSpPr/>
          <p:nvPr/>
        </p:nvSpPr>
        <p:spPr>
          <a:xfrm>
            <a:off x="5733757" y="2699064"/>
            <a:ext cx="1121767" cy="265871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01-02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1432" y="2727897"/>
            <a:ext cx="1242094" cy="1195579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7" name="Rectangle 56"/>
          <p:cNvSpPr/>
          <p:nvPr/>
        </p:nvSpPr>
        <p:spPr>
          <a:xfrm>
            <a:off x="7040922" y="2714584"/>
            <a:ext cx="1121767" cy="280112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02-04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3017" y="2746711"/>
            <a:ext cx="1198154" cy="1176765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9" name="Rectangle 58"/>
          <p:cNvSpPr/>
          <p:nvPr/>
        </p:nvSpPr>
        <p:spPr>
          <a:xfrm>
            <a:off x="8329434" y="2730038"/>
            <a:ext cx="1121767" cy="234897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01-01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7657" y="2767838"/>
            <a:ext cx="1278561" cy="114593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61" name="Rectangle 60"/>
          <p:cNvSpPr/>
          <p:nvPr/>
        </p:nvSpPr>
        <p:spPr>
          <a:xfrm>
            <a:off x="9616051" y="2730038"/>
            <a:ext cx="1121767" cy="238013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02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02673" y="2777545"/>
            <a:ext cx="1197812" cy="114593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63" name="Rectangle 62"/>
          <p:cNvSpPr/>
          <p:nvPr/>
        </p:nvSpPr>
        <p:spPr>
          <a:xfrm>
            <a:off x="10944210" y="2730038"/>
            <a:ext cx="1121767" cy="234897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N01-05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29" y="3963981"/>
            <a:ext cx="1322493" cy="1328455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66" name="Rectangle 65"/>
          <p:cNvSpPr/>
          <p:nvPr/>
        </p:nvSpPr>
        <p:spPr>
          <a:xfrm>
            <a:off x="162551" y="3934259"/>
            <a:ext cx="1121767" cy="296222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N02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Picture 64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1983" y="3988974"/>
            <a:ext cx="1358272" cy="128103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67" name="Rectangle 66"/>
          <p:cNvSpPr/>
          <p:nvPr/>
        </p:nvSpPr>
        <p:spPr>
          <a:xfrm>
            <a:off x="1469722" y="3957706"/>
            <a:ext cx="1139613" cy="284519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TA01-04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" name="Picture 67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5799" y="3988974"/>
            <a:ext cx="1405242" cy="128103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69" name="Rectangle 68"/>
          <p:cNvSpPr/>
          <p:nvPr/>
        </p:nvSpPr>
        <p:spPr>
          <a:xfrm>
            <a:off x="2888346" y="3955187"/>
            <a:ext cx="1139613" cy="275294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TA02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0" name="Picture 69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6585" y="3988974"/>
            <a:ext cx="1371792" cy="128103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1" name="Rectangle 70"/>
          <p:cNvSpPr/>
          <p:nvPr/>
        </p:nvSpPr>
        <p:spPr>
          <a:xfrm>
            <a:off x="4327313" y="3954276"/>
            <a:ext cx="1139613" cy="276205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1-02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2" name="Picture 71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5445" y="3988974"/>
            <a:ext cx="1263947" cy="128103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3" name="Rectangle 72"/>
          <p:cNvSpPr/>
          <p:nvPr/>
        </p:nvSpPr>
        <p:spPr>
          <a:xfrm>
            <a:off x="5668913" y="3955187"/>
            <a:ext cx="1139613" cy="274844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2-02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9929" y="3988974"/>
            <a:ext cx="1253556" cy="128103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5" name="Rectangle 74"/>
          <p:cNvSpPr/>
          <p:nvPr/>
        </p:nvSpPr>
        <p:spPr>
          <a:xfrm>
            <a:off x="7030256" y="3955186"/>
            <a:ext cx="1139613" cy="274845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3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7875" y="3988974"/>
            <a:ext cx="1189188" cy="128103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7" name="Rectangle 76"/>
          <p:cNvSpPr/>
          <p:nvPr/>
        </p:nvSpPr>
        <p:spPr>
          <a:xfrm>
            <a:off x="8307583" y="3972120"/>
            <a:ext cx="1139613" cy="251265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4-07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2680" y="3986362"/>
            <a:ext cx="1272775" cy="128369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9" name="Rectangle 78"/>
          <p:cNvSpPr/>
          <p:nvPr/>
        </p:nvSpPr>
        <p:spPr>
          <a:xfrm>
            <a:off x="9607127" y="3976628"/>
            <a:ext cx="1139613" cy="272810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5-16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0" name="Picture 79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14191" y="3986362"/>
            <a:ext cx="1186293" cy="1293376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81" name="Rectangle 80"/>
          <p:cNvSpPr/>
          <p:nvPr/>
        </p:nvSpPr>
        <p:spPr>
          <a:xfrm>
            <a:off x="10962676" y="3965240"/>
            <a:ext cx="1077805" cy="291650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6-06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3" name="Picture 82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16" y="5358220"/>
            <a:ext cx="1263831" cy="132907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84" name="Rectangle 83"/>
          <p:cNvSpPr/>
          <p:nvPr/>
        </p:nvSpPr>
        <p:spPr>
          <a:xfrm>
            <a:off x="131544" y="5304783"/>
            <a:ext cx="1111238" cy="250935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07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5" name="Group 84"/>
          <p:cNvGrpSpPr/>
          <p:nvPr/>
        </p:nvGrpSpPr>
        <p:grpSpPr>
          <a:xfrm>
            <a:off x="1381025" y="5292437"/>
            <a:ext cx="10719459" cy="1394856"/>
            <a:chOff x="19422" y="1274131"/>
            <a:chExt cx="10719459" cy="1394856"/>
          </a:xfrm>
        </p:grpSpPr>
        <p:pic>
          <p:nvPicPr>
            <p:cNvPr id="86" name="Picture 85"/>
            <p:cNvPicPr>
              <a:picLocks noChangeAspect="1"/>
            </p:cNvPicPr>
            <p:nvPr/>
          </p:nvPicPr>
          <p:blipFill>
            <a:blip r:embed="rId4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22" y="1328115"/>
              <a:ext cx="1328405" cy="134087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7" name="Rectangle 86"/>
            <p:cNvSpPr/>
            <p:nvPr/>
          </p:nvSpPr>
          <p:spPr>
            <a:xfrm>
              <a:off x="150047" y="1322171"/>
              <a:ext cx="1139613" cy="25700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08-0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8" name="Picture 87"/>
            <p:cNvPicPr>
              <a:picLocks noChangeAspect="1"/>
            </p:cNvPicPr>
            <p:nvPr/>
          </p:nvPicPr>
          <p:blipFill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09039" y="1328115"/>
              <a:ext cx="1388814" cy="134087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9" name="Rectangle 88"/>
            <p:cNvSpPr/>
            <p:nvPr/>
          </p:nvSpPr>
          <p:spPr>
            <a:xfrm>
              <a:off x="1542190" y="1305008"/>
              <a:ext cx="1139613" cy="23240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09-09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0" name="Picture 89"/>
            <p:cNvPicPr>
              <a:picLocks noChangeAspect="1"/>
            </p:cNvPicPr>
            <p:nvPr/>
          </p:nvPicPr>
          <p:blipFill>
            <a:blip r:embed="rId5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7281" y="1308838"/>
              <a:ext cx="1316469" cy="136014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1" name="Rectangle 90"/>
            <p:cNvSpPr/>
            <p:nvPr/>
          </p:nvSpPr>
          <p:spPr>
            <a:xfrm>
              <a:off x="2924705" y="1302894"/>
              <a:ext cx="1139613" cy="23451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0-06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5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89687" y="1274131"/>
              <a:ext cx="1330764" cy="139485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3" name="Rectangle 92"/>
            <p:cNvSpPr/>
            <p:nvPr/>
          </p:nvSpPr>
          <p:spPr>
            <a:xfrm>
              <a:off x="4323511" y="1282275"/>
              <a:ext cx="1139613" cy="25513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1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4" name="Picture 93"/>
            <p:cNvPicPr>
              <a:picLocks noChangeAspect="1"/>
            </p:cNvPicPr>
            <p:nvPr/>
          </p:nvPicPr>
          <p:blipFill>
            <a:blip r:embed="rId5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8525" y="1300341"/>
              <a:ext cx="1273358" cy="136864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5" name="Rectangle 94"/>
            <p:cNvSpPr/>
            <p:nvPr/>
          </p:nvSpPr>
          <p:spPr>
            <a:xfrm>
              <a:off x="5690654" y="1294397"/>
              <a:ext cx="1139613" cy="24301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2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5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5646" y="1294397"/>
              <a:ext cx="1240408" cy="137459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7" name="Rectangle 96"/>
            <p:cNvSpPr/>
            <p:nvPr/>
          </p:nvSpPr>
          <p:spPr>
            <a:xfrm>
              <a:off x="6958907" y="1279834"/>
              <a:ext cx="1139613" cy="27451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3-1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8" name="Picture 97"/>
            <p:cNvPicPr>
              <a:picLocks noChangeAspect="1"/>
            </p:cNvPicPr>
            <p:nvPr/>
          </p:nvPicPr>
          <p:blipFill>
            <a:blip r:embed="rId5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7454" y="1314634"/>
              <a:ext cx="1244152" cy="135435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9" name="Rectangle 98"/>
            <p:cNvSpPr/>
            <p:nvPr/>
          </p:nvSpPr>
          <p:spPr>
            <a:xfrm>
              <a:off x="8269724" y="1302894"/>
              <a:ext cx="1139613" cy="23451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4-29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0" name="Picture 99"/>
            <p:cNvPicPr>
              <a:picLocks noChangeAspect="1"/>
            </p:cNvPicPr>
            <p:nvPr/>
          </p:nvPicPr>
          <p:blipFill>
            <a:blip r:embed="rId5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19518" y="1322171"/>
              <a:ext cx="1219363" cy="134681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01" name="Rectangle 100"/>
            <p:cNvSpPr/>
            <p:nvPr/>
          </p:nvSpPr>
          <p:spPr>
            <a:xfrm>
              <a:off x="9604490" y="1316992"/>
              <a:ext cx="1002476" cy="22042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5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5187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41" y="61496"/>
            <a:ext cx="1184418" cy="127297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41" name="Rectangle 40"/>
          <p:cNvSpPr/>
          <p:nvPr/>
        </p:nvSpPr>
        <p:spPr>
          <a:xfrm>
            <a:off x="142231" y="61496"/>
            <a:ext cx="1019384" cy="21067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K16-12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9" name="Group 98"/>
          <p:cNvGrpSpPr/>
          <p:nvPr/>
        </p:nvGrpSpPr>
        <p:grpSpPr>
          <a:xfrm>
            <a:off x="1273974" y="28123"/>
            <a:ext cx="10794096" cy="1309495"/>
            <a:chOff x="62245" y="2652906"/>
            <a:chExt cx="10794096" cy="1309495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245" y="2666749"/>
              <a:ext cx="1328405" cy="129565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3" name="Rectangle 42"/>
            <p:cNvSpPr/>
            <p:nvPr/>
          </p:nvSpPr>
          <p:spPr>
            <a:xfrm>
              <a:off x="142231" y="2654883"/>
              <a:ext cx="1139613" cy="22696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7-10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1186" y="2666749"/>
              <a:ext cx="1324709" cy="129565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5" name="Rectangle 44"/>
            <p:cNvSpPr/>
            <p:nvPr/>
          </p:nvSpPr>
          <p:spPr>
            <a:xfrm>
              <a:off x="1543733" y="2666749"/>
              <a:ext cx="1139613" cy="251531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18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9921" y="2675553"/>
              <a:ext cx="1289487" cy="127804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7" name="Rectangle 46"/>
            <p:cNvSpPr/>
            <p:nvPr/>
          </p:nvSpPr>
          <p:spPr>
            <a:xfrm>
              <a:off x="2913362" y="2684953"/>
              <a:ext cx="1139613" cy="23332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1-1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9903" y="2666749"/>
              <a:ext cx="1404449" cy="129565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49" name="Rectangle 48"/>
            <p:cNvSpPr/>
            <p:nvPr/>
          </p:nvSpPr>
          <p:spPr>
            <a:xfrm>
              <a:off x="4317535" y="2684954"/>
              <a:ext cx="1139613" cy="23332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2-06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6546" y="2675553"/>
              <a:ext cx="1366057" cy="128684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1" name="Rectangle 50"/>
            <p:cNvSpPr/>
            <p:nvPr/>
          </p:nvSpPr>
          <p:spPr>
            <a:xfrm>
              <a:off x="5729385" y="2652906"/>
              <a:ext cx="1139613" cy="23038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3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54797" y="2684953"/>
              <a:ext cx="1251344" cy="127744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3" name="Rectangle 52"/>
            <p:cNvSpPr/>
            <p:nvPr/>
          </p:nvSpPr>
          <p:spPr>
            <a:xfrm>
              <a:off x="7085994" y="2653113"/>
              <a:ext cx="1139613" cy="22137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4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6119" y="2684953"/>
              <a:ext cx="1222188" cy="127744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5" name="Rectangle 54"/>
            <p:cNvSpPr/>
            <p:nvPr/>
          </p:nvSpPr>
          <p:spPr>
            <a:xfrm>
              <a:off x="8417406" y="2666749"/>
              <a:ext cx="1139613" cy="27436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5-18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32339" y="2688849"/>
              <a:ext cx="1224002" cy="127355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57" name="Rectangle 56"/>
            <p:cNvSpPr/>
            <p:nvPr/>
          </p:nvSpPr>
          <p:spPr>
            <a:xfrm>
              <a:off x="9674534" y="2652906"/>
              <a:ext cx="1139613" cy="28820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6-1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58" name="Picture 5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41" y="1390138"/>
            <a:ext cx="1184418" cy="1338331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59" name="Rectangle 58"/>
          <p:cNvSpPr/>
          <p:nvPr/>
        </p:nvSpPr>
        <p:spPr>
          <a:xfrm>
            <a:off x="106887" y="1370621"/>
            <a:ext cx="1015743" cy="253098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07-20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0" name="Group 99"/>
          <p:cNvGrpSpPr/>
          <p:nvPr/>
        </p:nvGrpSpPr>
        <p:grpSpPr>
          <a:xfrm>
            <a:off x="1298647" y="1379866"/>
            <a:ext cx="10781224" cy="1379497"/>
            <a:chOff x="75118" y="3981467"/>
            <a:chExt cx="10781224" cy="1379497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118" y="4002063"/>
              <a:ext cx="1315532" cy="135154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1" name="Rectangle 60"/>
            <p:cNvSpPr/>
            <p:nvPr/>
          </p:nvSpPr>
          <p:spPr>
            <a:xfrm>
              <a:off x="142231" y="4002063"/>
              <a:ext cx="1139613" cy="22325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08-1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1186" y="4002063"/>
              <a:ext cx="1338240" cy="13589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3" name="Rectangle 62"/>
            <p:cNvSpPr/>
            <p:nvPr/>
          </p:nvSpPr>
          <p:spPr>
            <a:xfrm>
              <a:off x="1543732" y="4011545"/>
              <a:ext cx="1139613" cy="21377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M01-0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9921" y="4002062"/>
              <a:ext cx="1302979" cy="135154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5" name="Rectangle 64"/>
            <p:cNvSpPr/>
            <p:nvPr/>
          </p:nvSpPr>
          <p:spPr>
            <a:xfrm>
              <a:off x="2942407" y="4011545"/>
              <a:ext cx="1139613" cy="21377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M02-1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9634" y="4010867"/>
              <a:ext cx="1383004" cy="135009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7" name="Rectangle 66"/>
            <p:cNvSpPr/>
            <p:nvPr/>
          </p:nvSpPr>
          <p:spPr>
            <a:xfrm>
              <a:off x="4315021" y="4011545"/>
              <a:ext cx="1139613" cy="21377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M03-09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21514" y="4010866"/>
              <a:ext cx="1350283" cy="135009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1" name="Rectangle 70"/>
            <p:cNvSpPr/>
            <p:nvPr/>
          </p:nvSpPr>
          <p:spPr>
            <a:xfrm>
              <a:off x="5720977" y="4011545"/>
              <a:ext cx="1139613" cy="21377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1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2603" y="4020268"/>
              <a:ext cx="1312930" cy="1340696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3" name="Rectangle 72"/>
            <p:cNvSpPr/>
            <p:nvPr/>
          </p:nvSpPr>
          <p:spPr>
            <a:xfrm>
              <a:off x="7124244" y="4002062"/>
              <a:ext cx="1139613" cy="22325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2-1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4" name="Picture 73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6119" y="3998343"/>
              <a:ext cx="1222188" cy="135526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5" name="Rectangle 74"/>
            <p:cNvSpPr/>
            <p:nvPr/>
          </p:nvSpPr>
          <p:spPr>
            <a:xfrm>
              <a:off x="8409496" y="3991739"/>
              <a:ext cx="1139613" cy="27847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3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6" name="Picture 75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50276" y="3998344"/>
              <a:ext cx="1206066" cy="136262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77" name="Rectangle 76"/>
            <p:cNvSpPr/>
            <p:nvPr/>
          </p:nvSpPr>
          <p:spPr>
            <a:xfrm>
              <a:off x="9677853" y="3981467"/>
              <a:ext cx="1139613" cy="243853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4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78" name="Picture 77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52" y="2788577"/>
            <a:ext cx="1193541" cy="1330039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79" name="Rectangle 78"/>
          <p:cNvSpPr/>
          <p:nvPr/>
        </p:nvSpPr>
        <p:spPr>
          <a:xfrm>
            <a:off x="110256" y="2792771"/>
            <a:ext cx="1049436" cy="230454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05-05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1" name="Group 100"/>
          <p:cNvGrpSpPr/>
          <p:nvPr/>
        </p:nvGrpSpPr>
        <p:grpSpPr>
          <a:xfrm>
            <a:off x="1285775" y="2756686"/>
            <a:ext cx="10782295" cy="1361930"/>
            <a:chOff x="74046" y="5389550"/>
            <a:chExt cx="10782295" cy="135519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046" y="5404513"/>
              <a:ext cx="1316603" cy="1340232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0" name="Rectangle 79"/>
            <p:cNvSpPr/>
            <p:nvPr/>
          </p:nvSpPr>
          <p:spPr>
            <a:xfrm>
              <a:off x="142231" y="5430700"/>
              <a:ext cx="1139613" cy="21882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6-1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29109" y="5430701"/>
              <a:ext cx="1346785" cy="131404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1" name="Rectangle 80"/>
            <p:cNvSpPr/>
            <p:nvPr/>
          </p:nvSpPr>
          <p:spPr>
            <a:xfrm>
              <a:off x="1499454" y="5430700"/>
              <a:ext cx="1139613" cy="25393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7-08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2747" y="5430701"/>
              <a:ext cx="1306661" cy="131404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2" name="Rectangle 81"/>
            <p:cNvSpPr/>
            <p:nvPr/>
          </p:nvSpPr>
          <p:spPr>
            <a:xfrm>
              <a:off x="2892231" y="5430700"/>
              <a:ext cx="1139613" cy="26304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8-1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9" name="Picture 68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3361" y="5430699"/>
              <a:ext cx="1362932" cy="131404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3" name="Rectangle 82"/>
            <p:cNvSpPr/>
            <p:nvPr/>
          </p:nvSpPr>
          <p:spPr>
            <a:xfrm>
              <a:off x="4310925" y="5430700"/>
              <a:ext cx="1139613" cy="218827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09-06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0" name="Picture 69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08490" y="5433833"/>
              <a:ext cx="1363307" cy="129839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4" name="Rectangle 83"/>
            <p:cNvSpPr/>
            <p:nvPr/>
          </p:nvSpPr>
          <p:spPr>
            <a:xfrm>
              <a:off x="5729385" y="5430699"/>
              <a:ext cx="1139613" cy="25393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10-06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5" name="Picture 84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3994" y="5430699"/>
              <a:ext cx="1311538" cy="130152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6" name="Rectangle 85"/>
            <p:cNvSpPr/>
            <p:nvPr/>
          </p:nvSpPr>
          <p:spPr>
            <a:xfrm>
              <a:off x="7110663" y="5430699"/>
              <a:ext cx="1139613" cy="25393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11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7" name="Picture 86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6120" y="5404512"/>
              <a:ext cx="1205046" cy="132771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8" name="Rectangle 87"/>
            <p:cNvSpPr/>
            <p:nvPr/>
          </p:nvSpPr>
          <p:spPr>
            <a:xfrm>
              <a:off x="8408836" y="5389550"/>
              <a:ext cx="1139613" cy="25997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12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9" name="Picture 8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59794" y="5404513"/>
              <a:ext cx="1196547" cy="132771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90" name="Rectangle 89"/>
            <p:cNvSpPr/>
            <p:nvPr/>
          </p:nvSpPr>
          <p:spPr>
            <a:xfrm>
              <a:off x="9674532" y="5404512"/>
              <a:ext cx="1139613" cy="24501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13-02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1" name="Picture 90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73" y="4167889"/>
            <a:ext cx="1196097" cy="1221661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92" name="Rectangle 91"/>
          <p:cNvSpPr/>
          <p:nvPr/>
        </p:nvSpPr>
        <p:spPr>
          <a:xfrm>
            <a:off x="99666" y="4157493"/>
            <a:ext cx="1074462" cy="258523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14-03</a:t>
            </a:r>
            <a:endParaRPr lang="fa-I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2" name="Group 101"/>
          <p:cNvGrpSpPr/>
          <p:nvPr/>
        </p:nvGrpSpPr>
        <p:grpSpPr>
          <a:xfrm>
            <a:off x="1302325" y="4128461"/>
            <a:ext cx="10749823" cy="1324514"/>
            <a:chOff x="72022" y="13480"/>
            <a:chExt cx="10749823" cy="1324514"/>
          </a:xfrm>
        </p:grpSpPr>
        <p:pic>
          <p:nvPicPr>
            <p:cNvPr id="103" name="Picture 102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1208" y="36104"/>
              <a:ext cx="1344881" cy="127461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04" name="Rectangle 103"/>
            <p:cNvSpPr/>
            <p:nvPr/>
          </p:nvSpPr>
          <p:spPr>
            <a:xfrm>
              <a:off x="2924829" y="13480"/>
              <a:ext cx="1139613" cy="231171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17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5" name="Group 104"/>
            <p:cNvGrpSpPr/>
            <p:nvPr/>
          </p:nvGrpSpPr>
          <p:grpSpPr>
            <a:xfrm>
              <a:off x="72022" y="13480"/>
              <a:ext cx="10749823" cy="1324514"/>
              <a:chOff x="72022" y="13480"/>
              <a:chExt cx="10749823" cy="1324514"/>
            </a:xfrm>
          </p:grpSpPr>
          <p:pic>
            <p:nvPicPr>
              <p:cNvPr id="106" name="Picture 105"/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022" y="41564"/>
                <a:ext cx="1299826" cy="1255303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07" name="Rectangle 106"/>
              <p:cNvSpPr/>
              <p:nvPr/>
            </p:nvSpPr>
            <p:spPr>
              <a:xfrm>
                <a:off x="128394" y="39040"/>
                <a:ext cx="1080374" cy="261996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15-04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08" name="Picture 107"/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29062" y="36104"/>
                <a:ext cx="1329791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09" name="Rectangle 108"/>
              <p:cNvSpPr/>
              <p:nvPr/>
            </p:nvSpPr>
            <p:spPr>
              <a:xfrm>
                <a:off x="1512964" y="21090"/>
                <a:ext cx="1139613" cy="250498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16-02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0" name="Picture 109"/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95100" y="36104"/>
                <a:ext cx="1343815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11" name="Rectangle 110"/>
              <p:cNvSpPr/>
              <p:nvPr/>
            </p:nvSpPr>
            <p:spPr>
              <a:xfrm>
                <a:off x="4364515" y="13480"/>
                <a:ext cx="1139613" cy="231171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18-03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2" name="Picture 111"/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09787" y="22249"/>
                <a:ext cx="1355236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13" name="Rectangle 112"/>
              <p:cNvSpPr/>
              <p:nvPr/>
            </p:nvSpPr>
            <p:spPr>
              <a:xfrm>
                <a:off x="5717598" y="22104"/>
                <a:ext cx="1139613" cy="239391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19-03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4" name="Picture 113"/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12575" y="22249"/>
                <a:ext cx="1322244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15" name="Rectangle 114"/>
              <p:cNvSpPr/>
              <p:nvPr/>
            </p:nvSpPr>
            <p:spPr>
              <a:xfrm>
                <a:off x="7046651" y="27383"/>
                <a:ext cx="1139613" cy="234112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20-01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6" name="Picture 115"/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23298" y="63376"/>
                <a:ext cx="1298459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17" name="Rectangle 116"/>
              <p:cNvSpPr/>
              <p:nvPr/>
            </p:nvSpPr>
            <p:spPr>
              <a:xfrm>
                <a:off x="8389529" y="36104"/>
                <a:ext cx="1085764" cy="225391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21-09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8" name="Picture 117"/>
              <p:cNvPicPr>
                <a:picLocks noChangeAspect="1"/>
              </p:cNvPicPr>
              <p:nvPr/>
            </p:nvPicPr>
            <p:blipFill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623847" y="52858"/>
                <a:ext cx="1197998" cy="1274618"/>
              </a:xfrm>
              <a:prstGeom prst="rect">
                <a:avLst/>
              </a:prstGeom>
              <a:ln w="38100" cap="sq">
                <a:solidFill>
                  <a:srgbClr val="000000"/>
                </a:solidFill>
                <a:prstDash val="solid"/>
                <a:miter lim="800000"/>
              </a:ln>
              <a:effectLst>
                <a:outerShdw blurRad="50800" dist="38100" dir="2700000" algn="tl" rotWithShape="0">
                  <a:srgbClr val="000000">
                    <a:alpha val="43000"/>
                  </a:srgbClr>
                </a:outerShdw>
              </a:effectLst>
            </p:spPr>
          </p:pic>
          <p:sp>
            <p:nvSpPr>
              <p:cNvPr id="119" name="Rectangle 118"/>
              <p:cNvSpPr/>
              <p:nvPr/>
            </p:nvSpPr>
            <p:spPr>
              <a:xfrm>
                <a:off x="9698155" y="22211"/>
                <a:ext cx="1027631" cy="208547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1" anchor="ctr"/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22-02</a:t>
                </a:r>
                <a:endParaRPr lang="fa-I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20" name="Group 119"/>
          <p:cNvGrpSpPr/>
          <p:nvPr/>
        </p:nvGrpSpPr>
        <p:grpSpPr>
          <a:xfrm>
            <a:off x="66491" y="5425703"/>
            <a:ext cx="1238782" cy="1274618"/>
            <a:chOff x="10833768" y="52858"/>
            <a:chExt cx="1318815" cy="1274618"/>
          </a:xfrm>
        </p:grpSpPr>
        <p:pic>
          <p:nvPicPr>
            <p:cNvPr id="121" name="Picture 120"/>
            <p:cNvPicPr>
              <a:picLocks noChangeAspect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33768" y="52858"/>
              <a:ext cx="1318815" cy="127461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2" name="Rectangle 121"/>
            <p:cNvSpPr/>
            <p:nvPr/>
          </p:nvSpPr>
          <p:spPr>
            <a:xfrm>
              <a:off x="10890694" y="52894"/>
              <a:ext cx="1139613" cy="25627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3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" name="Group 122"/>
          <p:cNvGrpSpPr/>
          <p:nvPr/>
        </p:nvGrpSpPr>
        <p:grpSpPr>
          <a:xfrm>
            <a:off x="1265856" y="5411848"/>
            <a:ext cx="10786292" cy="1331844"/>
            <a:chOff x="18102" y="1327476"/>
            <a:chExt cx="10786292" cy="1331844"/>
          </a:xfrm>
        </p:grpSpPr>
        <p:pic>
          <p:nvPicPr>
            <p:cNvPr id="124" name="Picture 123"/>
            <p:cNvPicPr>
              <a:picLocks noChangeAspect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02" y="1363205"/>
              <a:ext cx="1336295" cy="1285539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5" name="Rectangle 124"/>
            <p:cNvSpPr/>
            <p:nvPr/>
          </p:nvSpPr>
          <p:spPr>
            <a:xfrm>
              <a:off x="128394" y="1366087"/>
              <a:ext cx="1083581" cy="26072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4-0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6" name="Picture 125"/>
            <p:cNvPicPr>
              <a:picLocks noChangeAspect="1"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01319" y="1363207"/>
              <a:ext cx="1363882" cy="128553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7" name="Rectangle 126"/>
            <p:cNvSpPr/>
            <p:nvPr/>
          </p:nvSpPr>
          <p:spPr>
            <a:xfrm>
              <a:off x="1496669" y="1345752"/>
              <a:ext cx="1139613" cy="281064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5-01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8" name="Picture 127"/>
            <p:cNvPicPr>
              <a:picLocks noChangeAspect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2139" y="1346826"/>
              <a:ext cx="1372998" cy="129960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29" name="Rectangle 128"/>
            <p:cNvSpPr/>
            <p:nvPr/>
          </p:nvSpPr>
          <p:spPr>
            <a:xfrm>
              <a:off x="2857578" y="1327476"/>
              <a:ext cx="1139613" cy="29934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6-03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0" name="Picture 129"/>
            <p:cNvPicPr>
              <a:picLocks noChangeAspect="1"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2572" y="1387319"/>
              <a:ext cx="1310692" cy="1272001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1" name="Rectangle 130"/>
            <p:cNvSpPr/>
            <p:nvPr/>
          </p:nvSpPr>
          <p:spPr>
            <a:xfrm>
              <a:off x="4285388" y="1356456"/>
              <a:ext cx="1139613" cy="284250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7-05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2" name="Picture 131"/>
            <p:cNvPicPr>
              <a:picLocks noChangeAspect="1"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70198" y="1376093"/>
              <a:ext cx="1384519" cy="128322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3" name="Rectangle 132"/>
            <p:cNvSpPr/>
            <p:nvPr/>
          </p:nvSpPr>
          <p:spPr>
            <a:xfrm>
              <a:off x="5739274" y="1379244"/>
              <a:ext cx="1139613" cy="24757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8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4" name="Picture 133"/>
            <p:cNvPicPr>
              <a:picLocks noChangeAspect="1"/>
            </p:cNvPicPr>
            <p:nvPr/>
          </p:nvPicPr>
          <p:blipFill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95123" y="1399527"/>
              <a:ext cx="1285375" cy="1243694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5" name="Rectangle 134"/>
            <p:cNvSpPr/>
            <p:nvPr/>
          </p:nvSpPr>
          <p:spPr>
            <a:xfrm>
              <a:off x="7056903" y="1366087"/>
              <a:ext cx="1139613" cy="26072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29-0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6" name="Picture 135"/>
            <p:cNvPicPr>
              <a:picLocks noChangeAspect="1"/>
            </p:cNvPicPr>
            <p:nvPr/>
          </p:nvPicPr>
          <p:blipFill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7933" y="1414644"/>
              <a:ext cx="1227595" cy="1228577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7" name="Rectangle 136"/>
            <p:cNvSpPr/>
            <p:nvPr/>
          </p:nvSpPr>
          <p:spPr>
            <a:xfrm>
              <a:off x="8389862" y="1397384"/>
              <a:ext cx="1113696" cy="24332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0-07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8" name="Picture 137"/>
            <p:cNvPicPr>
              <a:picLocks noChangeAspect="1"/>
            </p:cNvPicPr>
            <p:nvPr/>
          </p:nvPicPr>
          <p:blipFill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12923" y="1419893"/>
              <a:ext cx="1191471" cy="1226538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39" name="Rectangle 138"/>
            <p:cNvSpPr/>
            <p:nvPr/>
          </p:nvSpPr>
          <p:spPr>
            <a:xfrm>
              <a:off x="9680704" y="1366087"/>
              <a:ext cx="972598" cy="26072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1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32-14</a:t>
              </a:r>
              <a:endParaRPr lang="fa-I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26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152</Words>
  <Application>Microsoft Macintosh PowerPoint</Application>
  <PresentationFormat>Widescreen</PresentationFormat>
  <Paragraphs>12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oorche 30 DV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www.Win2Farsi.com</dc:creator>
  <cp:lastModifiedBy>Peter Poczai</cp:lastModifiedBy>
  <cp:revision>49</cp:revision>
  <dcterms:created xsi:type="dcterms:W3CDTF">2023-11-09T05:46:48Z</dcterms:created>
  <dcterms:modified xsi:type="dcterms:W3CDTF">2024-04-29T22:27:05Z</dcterms:modified>
</cp:coreProperties>
</file>